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978825784" r:id="rId2"/>
    <p:sldId id="1978825790" r:id="rId3"/>
    <p:sldId id="1978825794" r:id="rId4"/>
    <p:sldId id="1978825795" r:id="rId5"/>
    <p:sldId id="1978825796" r:id="rId6"/>
    <p:sldId id="1978825797" r:id="rId7"/>
    <p:sldId id="1978825798" r:id="rId8"/>
    <p:sldId id="1978825799" r:id="rId9"/>
    <p:sldId id="1978825800" r:id="rId10"/>
    <p:sldId id="1978825801" r:id="rId11"/>
    <p:sldId id="1978825802" r:id="rId12"/>
    <p:sldId id="1978825803" r:id="rId13"/>
    <p:sldId id="1978825804" r:id="rId14"/>
    <p:sldId id="1978825805" r:id="rId15"/>
    <p:sldId id="1978825809" r:id="rId16"/>
    <p:sldId id="1978825807" r:id="rId17"/>
    <p:sldId id="1978825810" r:id="rId18"/>
    <p:sldId id="1978825811" r:id="rId19"/>
    <p:sldId id="1978825812" r:id="rId20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mc="http://schemas.openxmlformats.org/markup-compatibility/2006" xmlns:c="http://schemas.openxmlformats.org/drawingml/2006/chart" xmlns:ns6="http://schemas.openxmlformats.org/drawingml/2006/chartDrawing" xmlns:dgm="http://schemas.openxmlformats.org/drawingml/2006/diagram" xmlns:pic="http://schemas.openxmlformats.org/drawingml/2006/picture" xmlns:wp="http://schemas.openxmlformats.org/drawingml/2006/wordprocessingDrawing" xmlns:xdr="http://schemas.openxmlformats.org/drawingml/2006/spreadsheetDrawing" xmlns:ns11="http://schemas.openxmlformats.org/drawingml/2006/compatibility" xmlns:ns12="http://schemas.openxmlformats.org/drawingml/2006/lockedCanvas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-68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444769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774421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604881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506665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729343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988440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55831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048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82490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9963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000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110EA-6548-4EF6-B0A9-8F847AEECEDD}" type="datetimeFigureOut">
              <a:rPr lang="fr-FR" smtClean="0"/>
              <a:t>10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AABF0-D73A-43C1-84CC-8A30B65353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0819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8" r:id="rId9"/>
    <p:sldLayoutId id="2147483659" r:id="rId10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1329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1812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4255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1453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8749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3274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0587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1154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4032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1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647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46" r="20157"/>
          <a:stretch/>
        </p:blipFill>
        <p:spPr bwMode="auto">
          <a:xfrm>
            <a:off x="4148050" y="1215562"/>
            <a:ext cx="3798917" cy="2749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" name="Group 5"/>
          <p:cNvGrpSpPr/>
          <p:nvPr/>
        </p:nvGrpSpPr>
        <p:grpSpPr>
          <a:xfrm>
            <a:off x="3344456" y="1040161"/>
            <a:ext cx="562526" cy="2318954"/>
            <a:chOff x="6823332" y="2605091"/>
            <a:chExt cx="562526" cy="2318954"/>
          </a:xfrm>
        </p:grpSpPr>
        <p:pic>
          <p:nvPicPr>
            <p:cNvPr id="6149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983831" y="3444592"/>
              <a:ext cx="2241527" cy="5625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6895242" y="2615721"/>
              <a:ext cx="418704" cy="23083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9</a:t>
              </a:r>
            </a:p>
            <a:p>
              <a:r>
                <a:rPr lang="en-US" dirty="0" smtClean="0"/>
                <a:t>10</a:t>
              </a:r>
            </a:p>
            <a:p>
              <a:r>
                <a:rPr lang="en-US" dirty="0" smtClean="0"/>
                <a:t>11</a:t>
              </a:r>
            </a:p>
            <a:p>
              <a:r>
                <a:rPr lang="en-US" dirty="0" smtClean="0"/>
                <a:t>12</a:t>
              </a:r>
            </a:p>
            <a:p>
              <a:r>
                <a:rPr lang="en-US" dirty="0" smtClean="0"/>
                <a:t>13</a:t>
              </a:r>
            </a:p>
            <a:p>
              <a:r>
                <a:rPr lang="en-US" dirty="0" smtClean="0"/>
                <a:t>14</a:t>
              </a:r>
            </a:p>
            <a:p>
              <a:r>
                <a:rPr lang="en-US" dirty="0" smtClean="0"/>
                <a:t>15</a:t>
              </a:r>
            </a:p>
            <a:p>
              <a:r>
                <a:rPr lang="en-US" dirty="0" smtClean="0"/>
                <a:t>16</a:t>
              </a:r>
            </a:p>
          </p:txBody>
        </p:sp>
      </p:grpSp>
      <p:sp>
        <p:nvSpPr>
          <p:cNvPr id="7" name="Rectangle 6"/>
          <p:cNvSpPr/>
          <p:nvPr/>
        </p:nvSpPr>
        <p:spPr>
          <a:xfrm>
            <a:off x="1630680" y="3879298"/>
            <a:ext cx="902208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 </a:t>
            </a:r>
          </a:p>
          <a:p>
            <a:r>
              <a:rPr lang="en-US" dirty="0"/>
              <a:t> </a:t>
            </a:r>
          </a:p>
          <a:p>
            <a:r>
              <a:rPr lang="en-US" dirty="0" smtClean="0"/>
              <a:t>Heat </a:t>
            </a:r>
            <a:r>
              <a:rPr lang="en-US" dirty="0"/>
              <a:t>map of the </a:t>
            </a:r>
            <a:r>
              <a:rPr lang="en-US" i="1" dirty="0"/>
              <a:t>EGFR</a:t>
            </a:r>
            <a:r>
              <a:rPr lang="en-US" dirty="0"/>
              <a:t> and </a:t>
            </a:r>
            <a:r>
              <a:rPr lang="en-US" i="1" dirty="0"/>
              <a:t>ERBB3</a:t>
            </a:r>
            <a:r>
              <a:rPr lang="en-US" dirty="0"/>
              <a:t> expression log2 expression by </a:t>
            </a:r>
            <a:r>
              <a:rPr lang="en-US" dirty="0" err="1"/>
              <a:t>RNAseq</a:t>
            </a:r>
            <a:r>
              <a:rPr lang="en-US" dirty="0"/>
              <a:t>. Dark red indicates low expression where yellow indicates high expression.</a:t>
            </a:r>
          </a:p>
        </p:txBody>
      </p:sp>
      <p:sp>
        <p:nvSpPr>
          <p:cNvPr id="3" name="Rectangle 2"/>
          <p:cNvSpPr/>
          <p:nvPr/>
        </p:nvSpPr>
        <p:spPr>
          <a:xfrm>
            <a:off x="4214020" y="246491"/>
            <a:ext cx="25138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18. </a:t>
            </a:r>
          </a:p>
        </p:txBody>
      </p:sp>
    </p:spTree>
    <p:extLst>
      <p:ext uri="{BB962C8B-B14F-4D97-AF65-F5344CB8AC3E}">
        <p14:creationId xmlns:p14="http://schemas.microsoft.com/office/powerpoint/2010/main" val="2946396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838195" y="2743994"/>
          <a:ext cx="10515611" cy="244736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63403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  <a:gridCol w="368842"/>
              </a:tblGrid>
              <a:tr h="260359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ISQ summary of tumor specimens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009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041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079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085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07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14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44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47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65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180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227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235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239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255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B-277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BRL-451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58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64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68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83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85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094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107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CJBCR-109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iospecimen typ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olid tumor tissu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natomical sit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east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isease status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Invasive ductal carcinoma of the breast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lnical characteristics of patient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Not applicabl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Vital state of patient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ee manuscript table 1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linical diagnosis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east cancer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athological diagnosis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HER2+ breast cancer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ollection mechanism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urgical biopsy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ype of stabilization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Flash frozen in liquid nitrogen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ype of long-term presevation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tored -80C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onstituion of preservation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ryovials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torage temperatur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nus 80C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hipping temperatur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ry ice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6215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omposition assessment and selection </a:t>
                      </a:r>
                      <a:endParaRPr lang="en-US" sz="6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gridSpan="24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HER2+ confirmed by IHC and/or FISH</a:t>
                      </a:r>
                      <a:endParaRPr lang="en-US" sz="6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9054" marR="39054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4919927" y="1546163"/>
            <a:ext cx="2183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Tabl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1978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5048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2556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23445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348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0751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9353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5525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2881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12191997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4735" y="-118112"/>
            <a:ext cx="2286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3771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53</TotalTime>
  <Words>177</Words>
  <Application>Microsoft Office PowerPoint</Application>
  <PresentationFormat>Custom</PresentationFormat>
  <Paragraphs>83</Paragraphs>
  <Slides>1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0" baseType="lpstr"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vid Gohel</dc:creator>
  <cp:lastModifiedBy>George  Vasmatzis</cp:lastModifiedBy>
  <cp:revision>24</cp:revision>
  <dcterms:created xsi:type="dcterms:W3CDTF">2013-11-21T15:46:01Z</dcterms:created>
  <dcterms:modified xsi:type="dcterms:W3CDTF">2018-05-16T16:44:04Z</dcterms:modified>
</cp:coreProperties>
</file>